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4615"/>
  </p:normalViewPr>
  <p:slideViewPr>
    <p:cSldViewPr snapToGrid="0" snapToObjects="1">
      <p:cViewPr varScale="1">
        <p:scale>
          <a:sx n="83" d="100"/>
          <a:sy n="83" d="100"/>
        </p:scale>
        <p:origin x="116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49307C-A5E1-0640-8B5A-CCC73B0B2D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537057C-A552-0248-BAF3-DE883F98D9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FEC895-40A2-7A49-B3F5-BC26496CCE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CDA6-3CCE-0E48-84BB-2C70E2744186}" type="datetimeFigureOut">
              <a:rPr lang="en-US" smtClean="0"/>
              <a:t>12/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6603C9-CB3A-7946-A549-445CC9D24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672D6D-6444-314E-83E4-EBC2FCDA6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6C4D6-1E4D-DB4A-875E-1DBF42697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0647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33C479-004F-9C4F-B335-E827ADBB08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119D2A-A659-EC4E-80E8-023C217AFB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47CEA0-BD97-D34F-8B9B-EE31DAEEEB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CDA6-3CCE-0E48-84BB-2C70E2744186}" type="datetimeFigureOut">
              <a:rPr lang="en-US" smtClean="0"/>
              <a:t>12/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615050-5615-E74C-86AA-95BBA57808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2E8A05-9C9E-C84E-AEC9-737A41887C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6C4D6-1E4D-DB4A-875E-1DBF42697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407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F19071D-0FE0-754D-A811-7AAD5D64D2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1B4678-BDA1-6044-AD3D-A4EA5A1D11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95897A-C5B9-4245-9201-580F7EAE7E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CDA6-3CCE-0E48-84BB-2C70E2744186}" type="datetimeFigureOut">
              <a:rPr lang="en-US" smtClean="0"/>
              <a:t>12/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D32D20-0A1F-3240-8474-3990ECA62C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6D67AF-B1A4-8B47-B6EF-B7D332B206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6C4D6-1E4D-DB4A-875E-1DBF42697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598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11F6D9-337C-734E-A91F-58889E710C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466343-B840-334C-8C30-61F97AF34E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5234F0-DCC7-EA43-A70A-7B1B1797F7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CDA6-3CCE-0E48-84BB-2C70E2744186}" type="datetimeFigureOut">
              <a:rPr lang="en-US" smtClean="0"/>
              <a:t>12/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FDC159-1F57-F947-AD48-755903AB9C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9C9DB9-B89C-B94C-90CA-76139CE499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6C4D6-1E4D-DB4A-875E-1DBF42697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678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B3B04A-E814-7D40-9514-274E8077B5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ECB291-B13B-6A4D-87C1-A2CF1E6E70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F22EEA-DC36-3440-918F-0F11F1343B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CDA6-3CCE-0E48-84BB-2C70E2744186}" type="datetimeFigureOut">
              <a:rPr lang="en-US" smtClean="0"/>
              <a:t>12/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3CC1F4-E9A1-5841-B85D-685BC070CB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C44930-76C1-BE43-BF39-3DC32C9865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6C4D6-1E4D-DB4A-875E-1DBF42697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812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E518D7-6AF0-DE4D-A78B-E4414424EF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C0BF98-48DB-0B4E-B2AD-D24DBB932F0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CA1924-6C49-484E-9C89-1D5942CA63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C73CC0-B637-FD43-9C0B-D2658AEBEC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CDA6-3CCE-0E48-84BB-2C70E2744186}" type="datetimeFigureOut">
              <a:rPr lang="en-US" smtClean="0"/>
              <a:t>12/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A31347-7DC3-FA4B-93AD-1FF3EB8D04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559202-B78E-9448-A6C0-D2C22705E8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6C4D6-1E4D-DB4A-875E-1DBF42697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6508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4EBF48-71E6-AD4B-B663-239FF16386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A517A9-4299-2F40-BF0C-892A6EB8A0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CBB03A-C646-BB47-B3FE-D0FB1F9C39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6395F59-A75B-A24E-A0D9-FC6A2EAE64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EAA9D8E-F06D-D44D-875B-855836850E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8476F41-B806-154C-A7ED-CAA7DC3D8A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CDA6-3CCE-0E48-84BB-2C70E2744186}" type="datetimeFigureOut">
              <a:rPr lang="en-US" smtClean="0"/>
              <a:t>12/4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009909-7003-6A4E-B3FC-134B9F8B7A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97A85B2-34E1-854B-AC21-465572B7EB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6C4D6-1E4D-DB4A-875E-1DBF42697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219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6BBCF8-972E-8E45-843F-FAA92B33E5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1C42B42-D709-4846-A51B-6EB63D8BC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CDA6-3CCE-0E48-84BB-2C70E2744186}" type="datetimeFigureOut">
              <a:rPr lang="en-US" smtClean="0"/>
              <a:t>12/4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A4A9962-DFE8-3B47-BCEB-5D038BFE06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26F7D7E-74E6-8A4E-B609-0D1BF992E2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6C4D6-1E4D-DB4A-875E-1DBF42697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2367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9A04911-F431-2946-B17F-35AA3AA9B4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CDA6-3CCE-0E48-84BB-2C70E2744186}" type="datetimeFigureOut">
              <a:rPr lang="en-US" smtClean="0"/>
              <a:t>12/4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180BD35-EFB4-1C4A-B935-F2C2184AD0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F41FEE-0808-A04A-8BA2-6EBADC4ED3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6C4D6-1E4D-DB4A-875E-1DBF42697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479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A05144-361A-A54A-9E92-EAB4820E70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562CBD-B332-734A-A894-37539431C0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198B69-ABD0-F94A-A476-56DD7FCF9E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9364C5-9051-3340-9129-8FB576DF0C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CDA6-3CCE-0E48-84BB-2C70E2744186}" type="datetimeFigureOut">
              <a:rPr lang="en-US" smtClean="0"/>
              <a:t>12/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AAE579-696D-1543-86F8-9C1033655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9F22DA-D770-3448-B9E6-7F53CB8599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6C4D6-1E4D-DB4A-875E-1DBF42697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389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AC8E68-6D56-5D4E-81E5-7E4D65223F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87F33A-8E92-3F41-AA8B-1FE262142E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8C78B2-A09A-D044-9572-C01CF8D318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BFAB13-3818-6F49-B372-80644F52AB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D2CDA6-3CCE-0E48-84BB-2C70E2744186}" type="datetimeFigureOut">
              <a:rPr lang="en-US" smtClean="0"/>
              <a:t>12/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4E5943-DA78-144E-ADA3-EC8186A6A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4C28E5-86AC-CB43-8918-375BC34A11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36C4D6-1E4D-DB4A-875E-1DBF42697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0086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723C2D1-5B78-2E4E-80DC-C1FCBEC757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1D0F31-DA33-AD44-B8E7-DE6630F520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0B2D47-31F8-AA4D-B108-648616051F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D2CDA6-3CCE-0E48-84BB-2C70E2744186}" type="datetimeFigureOut">
              <a:rPr lang="en-US" smtClean="0"/>
              <a:t>12/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9CC727-328B-5B44-B755-3B332E30619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5301BB-EDC1-C24C-A56D-2D78B2AFC5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36C4D6-1E4D-DB4A-875E-1DBF426971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822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11" Type="http://schemas.openxmlformats.org/officeDocument/2006/relationships/image" Target="../media/image10.tiff"/><Relationship Id="rId5" Type="http://schemas.openxmlformats.org/officeDocument/2006/relationships/image" Target="../media/image4.ti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5">
            <a:extLst>
              <a:ext uri="{FF2B5EF4-FFF2-40B4-BE49-F238E27FC236}">
                <a16:creationId xmlns:a16="http://schemas.microsoft.com/office/drawing/2014/main" id="{078F546D-E306-E14A-B78E-04245BF40149}"/>
              </a:ext>
            </a:extLst>
          </p:cNvPr>
          <p:cNvSpPr txBox="1"/>
          <p:nvPr/>
        </p:nvSpPr>
        <p:spPr>
          <a:xfrm>
            <a:off x="4321834" y="163902"/>
            <a:ext cx="1155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I </a:t>
            </a:r>
            <a:endParaRPr lang="fr-B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97A56C94-5188-DD48-9C10-FA038D8AB04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8403" t="-5629" r="-11704" b="-6707"/>
          <a:stretch/>
        </p:blipFill>
        <p:spPr>
          <a:xfrm>
            <a:off x="91226" y="163902"/>
            <a:ext cx="4530240" cy="2525134"/>
          </a:xfrm>
          <a:prstGeom prst="rect">
            <a:avLst/>
          </a:prstGeom>
          <a:ln>
            <a:noFill/>
          </a:ln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05C83E07-201B-3E4F-92F5-7ECF7F974951}"/>
              </a:ext>
            </a:extLst>
          </p:cNvPr>
          <p:cNvSpPr txBox="1"/>
          <p:nvPr/>
        </p:nvSpPr>
        <p:spPr>
          <a:xfrm>
            <a:off x="4286278" y="1149470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x4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A6793281-435B-3E43-B9B4-3D25CCAC006A}"/>
              </a:ext>
            </a:extLst>
          </p:cNvPr>
          <p:cNvSpPr/>
          <p:nvPr/>
        </p:nvSpPr>
        <p:spPr>
          <a:xfrm>
            <a:off x="880725" y="1149470"/>
            <a:ext cx="2402237" cy="55399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2A3019A-0BE8-C84C-A39D-1A35F72C4055}"/>
              </a:ext>
            </a:extLst>
          </p:cNvPr>
          <p:cNvSpPr txBox="1"/>
          <p:nvPr/>
        </p:nvSpPr>
        <p:spPr>
          <a:xfrm>
            <a:off x="3615649" y="3148154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ufs1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84B6BA06-D877-4742-A429-025AF4EF417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5238" t="-17304" r="-6343" b="-16361"/>
          <a:stretch/>
        </p:blipFill>
        <p:spPr>
          <a:xfrm>
            <a:off x="416732" y="4102145"/>
            <a:ext cx="3330222" cy="2291644"/>
          </a:xfrm>
          <a:prstGeom prst="rect">
            <a:avLst/>
          </a:prstGeom>
          <a:ln>
            <a:noFill/>
          </a:ln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1D1EBFA7-1E0E-CC45-BC3C-3F43D0A80B53}"/>
              </a:ext>
            </a:extLst>
          </p:cNvPr>
          <p:cNvSpPr txBox="1"/>
          <p:nvPr/>
        </p:nvSpPr>
        <p:spPr>
          <a:xfrm>
            <a:off x="3606031" y="5663767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ufa2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22380A6B-B3CA-234E-883A-394A1E80F40E}"/>
              </a:ext>
            </a:extLst>
          </p:cNvPr>
          <p:cNvSpPr/>
          <p:nvPr/>
        </p:nvSpPr>
        <p:spPr>
          <a:xfrm>
            <a:off x="775095" y="5398088"/>
            <a:ext cx="2402237" cy="55399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444B5CC1-A9D3-294C-A3EC-84822DBEC21D}"/>
              </a:ext>
            </a:extLst>
          </p:cNvPr>
          <p:cNvSpPr/>
          <p:nvPr/>
        </p:nvSpPr>
        <p:spPr>
          <a:xfrm>
            <a:off x="775095" y="4726924"/>
            <a:ext cx="2402237" cy="55399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80E4B65-7000-A04B-9826-933DB4848FFB}"/>
              </a:ext>
            </a:extLst>
          </p:cNvPr>
          <p:cNvSpPr txBox="1"/>
          <p:nvPr/>
        </p:nvSpPr>
        <p:spPr>
          <a:xfrm>
            <a:off x="3602482" y="4865423"/>
            <a:ext cx="5084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ph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9F8804C9-2CB8-984A-92A9-B8C8C432A17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10024" t="-24081" r="-3225" b="-13896"/>
          <a:stretch/>
        </p:blipFill>
        <p:spPr>
          <a:xfrm>
            <a:off x="5959970" y="15618"/>
            <a:ext cx="2991556" cy="1174043"/>
          </a:xfrm>
          <a:prstGeom prst="rect">
            <a:avLst/>
          </a:prstGeom>
          <a:ln>
            <a:noFill/>
          </a:ln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E9D0A360-026E-1245-9126-5C43086C78F8}"/>
              </a:ext>
            </a:extLst>
          </p:cNvPr>
          <p:cNvSpPr txBox="1"/>
          <p:nvPr/>
        </p:nvSpPr>
        <p:spPr>
          <a:xfrm>
            <a:off x="8895281" y="420984"/>
            <a:ext cx="498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ns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1A619256-743F-E242-9BDC-103D281A6AA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3212" t="-19033" r="-4727" b="-16803"/>
          <a:stretch/>
        </p:blipFill>
        <p:spPr>
          <a:xfrm>
            <a:off x="6118579" y="1156638"/>
            <a:ext cx="2494844" cy="862574"/>
          </a:xfrm>
          <a:prstGeom prst="rect">
            <a:avLst/>
          </a:prstGeom>
          <a:ln>
            <a:noFill/>
          </a:ln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22E072BF-1212-6949-B09D-F3E60BE74C76}"/>
              </a:ext>
            </a:extLst>
          </p:cNvPr>
          <p:cNvSpPr txBox="1"/>
          <p:nvPr/>
        </p:nvSpPr>
        <p:spPr>
          <a:xfrm>
            <a:off x="8494575" y="1438328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dgh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29BC542C-EBAC-4546-A69B-68F9CB4A3F7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-7747" t="-5753" r="-10030" b="-26044"/>
          <a:stretch/>
        </p:blipFill>
        <p:spPr>
          <a:xfrm>
            <a:off x="6046034" y="2157757"/>
            <a:ext cx="2737242" cy="887133"/>
          </a:xfrm>
          <a:prstGeom prst="rect">
            <a:avLst/>
          </a:prstGeom>
          <a:ln>
            <a:noFill/>
          </a:ln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C3866782-9EC1-D74C-BB6A-E335DF152822}"/>
              </a:ext>
            </a:extLst>
          </p:cNvPr>
          <p:cNvSpPr txBox="1"/>
          <p:nvPr/>
        </p:nvSpPr>
        <p:spPr>
          <a:xfrm>
            <a:off x="8575267" y="2425126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at1</a:t>
            </a: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A69F1885-CDD3-E34B-AF71-9C9EB151DDF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-12646" t="-2021" r="-12416" b="-9881"/>
          <a:stretch/>
        </p:blipFill>
        <p:spPr>
          <a:xfrm>
            <a:off x="4458830" y="2853342"/>
            <a:ext cx="3319497" cy="1435360"/>
          </a:xfrm>
          <a:prstGeom prst="rect">
            <a:avLst/>
          </a:prstGeom>
          <a:ln>
            <a:noFill/>
          </a:ln>
        </p:spPr>
      </p:pic>
      <p:sp>
        <p:nvSpPr>
          <p:cNvPr id="51" name="Rectangle 50">
            <a:extLst>
              <a:ext uri="{FF2B5EF4-FFF2-40B4-BE49-F238E27FC236}">
                <a16:creationId xmlns:a16="http://schemas.microsoft.com/office/drawing/2014/main" id="{C86570BC-720E-3B40-9CCD-43B8947BAE0B}"/>
              </a:ext>
            </a:extLst>
          </p:cNvPr>
          <p:cNvSpPr/>
          <p:nvPr/>
        </p:nvSpPr>
        <p:spPr>
          <a:xfrm>
            <a:off x="4884669" y="3221784"/>
            <a:ext cx="2402237" cy="55399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51C182A-18F3-5D44-8751-0F4215EF7A80}"/>
              </a:ext>
            </a:extLst>
          </p:cNvPr>
          <p:cNvSpPr txBox="1"/>
          <p:nvPr/>
        </p:nvSpPr>
        <p:spPr>
          <a:xfrm>
            <a:off x="7602270" y="3335905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4Ebp1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6A00586C-792C-1940-A9D4-3BD821AA03C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-3445" t="-16767" r="-16792" b="-5737"/>
          <a:stretch/>
        </p:blipFill>
        <p:spPr>
          <a:xfrm>
            <a:off x="4638122" y="4079819"/>
            <a:ext cx="3160888" cy="995701"/>
          </a:xfrm>
          <a:prstGeom prst="rect">
            <a:avLst/>
          </a:prstGeom>
          <a:ln>
            <a:noFill/>
          </a:ln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689123AF-E32B-8248-AD28-EA2E64FD503E}"/>
              </a:ext>
            </a:extLst>
          </p:cNvPr>
          <p:cNvSpPr txBox="1"/>
          <p:nvPr/>
        </p:nvSpPr>
        <p:spPr>
          <a:xfrm>
            <a:off x="7334452" y="4577669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Ebp1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197F5F22-D64D-7348-BC56-E68789AA4E2A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2605" y="5187517"/>
            <a:ext cx="2819400" cy="952500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FAF4EDF8-39C2-AB40-BEA7-55B3B9F5D68C}"/>
              </a:ext>
            </a:extLst>
          </p:cNvPr>
          <p:cNvSpPr txBox="1"/>
          <p:nvPr/>
        </p:nvSpPr>
        <p:spPr>
          <a:xfrm>
            <a:off x="5945560" y="6134778"/>
            <a:ext cx="152097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90 (second membrane, not shown in Figure 1I)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B764E720-FC80-CD4E-B968-795E3BF693F9}"/>
              </a:ext>
            </a:extLst>
          </p:cNvPr>
          <p:cNvSpPr/>
          <p:nvPr/>
        </p:nvSpPr>
        <p:spPr>
          <a:xfrm>
            <a:off x="5340982" y="5568961"/>
            <a:ext cx="2402237" cy="22009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7" name="Picture 4">
            <a:extLst>
              <a:ext uri="{FF2B5EF4-FFF2-40B4-BE49-F238E27FC236}">
                <a16:creationId xmlns:a16="http://schemas.microsoft.com/office/drawing/2014/main" id="{F6573DDD-94A6-354B-AC5F-76044979809D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-6646" t="-14515" r="-3522" b="-15568"/>
          <a:stretch/>
        </p:blipFill>
        <p:spPr>
          <a:xfrm>
            <a:off x="8114374" y="2969494"/>
            <a:ext cx="3525826" cy="1354667"/>
          </a:xfrm>
          <a:prstGeom prst="rect">
            <a:avLst/>
          </a:prstGeom>
          <a:ln>
            <a:noFill/>
          </a:ln>
        </p:spPr>
      </p:pic>
      <p:pic>
        <p:nvPicPr>
          <p:cNvPr id="28" name="Picture 8">
            <a:extLst>
              <a:ext uri="{FF2B5EF4-FFF2-40B4-BE49-F238E27FC236}">
                <a16:creationId xmlns:a16="http://schemas.microsoft.com/office/drawing/2014/main" id="{6E6A9E3A-85D4-A041-A669-24A5E4AF5FD4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-8150" t="-8323" r="-6628" b="-8681"/>
          <a:stretch/>
        </p:blipFill>
        <p:spPr>
          <a:xfrm>
            <a:off x="8324680" y="4324161"/>
            <a:ext cx="3002845" cy="1396791"/>
          </a:xfrm>
          <a:prstGeom prst="rect">
            <a:avLst/>
          </a:prstGeom>
          <a:ln>
            <a:noFill/>
          </a:ln>
        </p:spPr>
      </p:pic>
      <p:sp>
        <p:nvSpPr>
          <p:cNvPr id="29" name="TextBox 22">
            <a:extLst>
              <a:ext uri="{FF2B5EF4-FFF2-40B4-BE49-F238E27FC236}">
                <a16:creationId xmlns:a16="http://schemas.microsoft.com/office/drawing/2014/main" id="{B2EC9BE1-69D6-5B47-AC40-F29F29299D79}"/>
              </a:ext>
            </a:extLst>
          </p:cNvPr>
          <p:cNvSpPr txBox="1"/>
          <p:nvPr/>
        </p:nvSpPr>
        <p:spPr>
          <a:xfrm>
            <a:off x="11487049" y="3419427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rd7</a:t>
            </a:r>
          </a:p>
        </p:txBody>
      </p:sp>
      <p:sp>
        <p:nvSpPr>
          <p:cNvPr id="30" name="TextBox 25">
            <a:extLst>
              <a:ext uri="{FF2B5EF4-FFF2-40B4-BE49-F238E27FC236}">
                <a16:creationId xmlns:a16="http://schemas.microsoft.com/office/drawing/2014/main" id="{4A17EE3C-3134-274C-95CA-C0CD964BF9C3}"/>
              </a:ext>
            </a:extLst>
          </p:cNvPr>
          <p:cNvSpPr txBox="1"/>
          <p:nvPr/>
        </p:nvSpPr>
        <p:spPr>
          <a:xfrm>
            <a:off x="11146414" y="4886794"/>
            <a:ext cx="60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90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8C18C83E-0A19-5641-915B-4192E06A357F}"/>
              </a:ext>
            </a:extLst>
          </p:cNvPr>
          <p:cNvSpPr/>
          <p:nvPr/>
        </p:nvSpPr>
        <p:spPr>
          <a:xfrm>
            <a:off x="8624983" y="3271084"/>
            <a:ext cx="2402237" cy="55399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2" name="Picture 4">
            <a:extLst>
              <a:ext uri="{FF2B5EF4-FFF2-40B4-BE49-F238E27FC236}">
                <a16:creationId xmlns:a16="http://schemas.microsoft.com/office/drawing/2014/main" id="{51D4762E-B6C5-2745-8552-C74AA0B37D1A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0411" t="25141" r="17235" b="25707"/>
          <a:stretch/>
        </p:blipFill>
        <p:spPr>
          <a:xfrm>
            <a:off x="755226" y="2870506"/>
            <a:ext cx="2692400" cy="1104900"/>
          </a:xfrm>
          <a:prstGeom prst="rect">
            <a:avLst/>
          </a:prstGeom>
        </p:spPr>
      </p:pic>
      <p:sp>
        <p:nvSpPr>
          <p:cNvPr id="33" name="Rectangle 32">
            <a:extLst>
              <a:ext uri="{FF2B5EF4-FFF2-40B4-BE49-F238E27FC236}">
                <a16:creationId xmlns:a16="http://schemas.microsoft.com/office/drawing/2014/main" id="{A6793281-435B-3E43-B9B4-3D25CCAC006A}"/>
              </a:ext>
            </a:extLst>
          </p:cNvPr>
          <p:cNvSpPr/>
          <p:nvPr/>
        </p:nvSpPr>
        <p:spPr>
          <a:xfrm>
            <a:off x="950693" y="3106444"/>
            <a:ext cx="2402237" cy="55399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2819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6</TotalTime>
  <Words>24</Words>
  <Application>Microsoft Macintosh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crosoft Office User</dc:creator>
  <cp:keywords/>
  <dc:description/>
  <cp:lastModifiedBy>Microsoft Office User</cp:lastModifiedBy>
  <cp:revision>2</cp:revision>
  <dcterms:created xsi:type="dcterms:W3CDTF">2025-12-04T07:53:49Z</dcterms:created>
  <dcterms:modified xsi:type="dcterms:W3CDTF">2025-12-05T15:00:02Z</dcterms:modified>
  <cp:category/>
</cp:coreProperties>
</file>